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78" r:id="rId2"/>
  </p:sldIdLst>
  <p:sldSz cx="12192000" cy="6858000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85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Emmanuel Margolin" initials="EM" lastIdx="7" clrIdx="0">
    <p:extLst>
      <p:ext uri="{19B8F6BF-5375-455C-9EA6-DF929625EA0E}">
        <p15:presenceInfo xmlns:p15="http://schemas.microsoft.com/office/powerpoint/2012/main" userId="Emmanuel Margolin" providerId="None"/>
      </p:ext>
    </p:extLst>
  </p:cmAuthor>
  <p:cmAuthor id="2" name="Ros Chapman" initials="RC" lastIdx="1" clrIdx="1">
    <p:extLst>
      <p:ext uri="{19B8F6BF-5375-455C-9EA6-DF929625EA0E}">
        <p15:presenceInfo xmlns:p15="http://schemas.microsoft.com/office/powerpoint/2012/main" userId="S::01405493@wf.uct.ac.za::cab73f8f-31f8-44ba-9513-55be69a5d063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173" autoAdjust="0"/>
    <p:restoredTop sz="88259" autoAdjust="0"/>
  </p:normalViewPr>
  <p:slideViewPr>
    <p:cSldViewPr>
      <p:cViewPr varScale="1">
        <p:scale>
          <a:sx n="59" d="100"/>
          <a:sy n="59" d="100"/>
        </p:scale>
        <p:origin x="1072" y="-388"/>
      </p:cViewPr>
      <p:guideLst>
        <p:guide orient="horz" pos="2160"/>
        <p:guide pos="388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notesMaster" Target="notesMasters/notesMaster1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handoutMaster" Target="handoutMasters/handoutMaster1.xml"/><Relationship Id="rId9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ZA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CA910E8-A1F0-4861-900D-A38BFFB21FE1}" type="datetimeFigureOut">
              <a:rPr lang="en-ZA" smtClean="0"/>
              <a:t>2021/05/13</a:t>
            </a:fld>
            <a:endParaRPr lang="en-Z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Z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7F7D5F4-3EC8-44C2-A5BA-EA81EDCE0751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136014180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ZA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82B6CC8-0703-4DB3-9D31-CD1F029393A9}" type="datetimeFigureOut">
              <a:rPr lang="en-ZA" smtClean="0"/>
              <a:t>2021/05/13</a:t>
            </a:fld>
            <a:endParaRPr lang="en-ZA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90488" y="744538"/>
            <a:ext cx="6616700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ZA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16463"/>
            <a:ext cx="5438775" cy="44672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48AA1C9-59C9-40E3-9A86-6A9F0D3546B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09790270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130430"/>
            <a:ext cx="103632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28803" y="3886200"/>
            <a:ext cx="85344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E713D0-FB24-4EC2-A65E-2690567B77E9}" type="datetimeFigureOut">
              <a:rPr lang="en-ZA" smtClean="0"/>
              <a:t>2021/05/13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BDA56-5D76-474F-9E22-EB45C3B9E71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7242854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E713D0-FB24-4EC2-A65E-2690567B77E9}" type="datetimeFigureOut">
              <a:rPr lang="en-ZA" smtClean="0"/>
              <a:t>2021/05/13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BDA56-5D76-474F-9E22-EB45C3B9E71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9722420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839200" y="274640"/>
            <a:ext cx="27432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09601" y="274640"/>
            <a:ext cx="80264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E713D0-FB24-4EC2-A65E-2690567B77E9}" type="datetimeFigureOut">
              <a:rPr lang="en-ZA" smtClean="0"/>
              <a:t>2021/05/13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BDA56-5D76-474F-9E22-EB45C3B9E71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307194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E713D0-FB24-4EC2-A65E-2690567B77E9}" type="datetimeFigureOut">
              <a:rPr lang="en-ZA" smtClean="0"/>
              <a:t>2021/05/13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BDA56-5D76-474F-9E22-EB45C3B9E71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40563074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63085" y="4406905"/>
            <a:ext cx="103632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63085" y="2906713"/>
            <a:ext cx="103632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E713D0-FB24-4EC2-A65E-2690567B77E9}" type="datetimeFigureOut">
              <a:rPr lang="en-ZA" smtClean="0"/>
              <a:t>2021/05/13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BDA56-5D76-474F-9E22-EB45C3B9E71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0211667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09601" y="1600205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7601" y="1600205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E713D0-FB24-4EC2-A65E-2690567B77E9}" type="datetimeFigureOut">
              <a:rPr lang="en-ZA" smtClean="0"/>
              <a:t>2021/05/13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BDA56-5D76-474F-9E22-EB45C3B9E71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1059650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1535113"/>
            <a:ext cx="538691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09600" y="2174875"/>
            <a:ext cx="538691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93370" y="1535113"/>
            <a:ext cx="5389033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93370" y="2174875"/>
            <a:ext cx="5389033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E713D0-FB24-4EC2-A65E-2690567B77E9}" type="datetimeFigureOut">
              <a:rPr lang="en-ZA" smtClean="0"/>
              <a:t>2021/05/13</a:t>
            </a:fld>
            <a:endParaRPr lang="en-Z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BDA56-5D76-474F-9E22-EB45C3B9E71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1233395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E713D0-FB24-4EC2-A65E-2690567B77E9}" type="datetimeFigureOut">
              <a:rPr lang="en-ZA" smtClean="0"/>
              <a:t>2021/05/13</a:t>
            </a:fld>
            <a:endParaRPr lang="en-Z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BDA56-5D76-474F-9E22-EB45C3B9E71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8775142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E713D0-FB24-4EC2-A65E-2690567B77E9}" type="datetimeFigureOut">
              <a:rPr lang="en-ZA" smtClean="0"/>
              <a:t>2021/05/13</a:t>
            </a:fld>
            <a:endParaRPr lang="en-Z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BDA56-5D76-474F-9E22-EB45C3B9E71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1702225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2" y="273050"/>
            <a:ext cx="4011084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766736" y="273053"/>
            <a:ext cx="6815667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09602" y="1435103"/>
            <a:ext cx="4011084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E713D0-FB24-4EC2-A65E-2690567B77E9}" type="datetimeFigureOut">
              <a:rPr lang="en-ZA" smtClean="0"/>
              <a:t>2021/05/13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BDA56-5D76-474F-9E22-EB45C3B9E71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7503600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389719" y="4800600"/>
            <a:ext cx="73152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389719" y="612775"/>
            <a:ext cx="73152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Z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389719" y="5367338"/>
            <a:ext cx="7315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E713D0-FB24-4EC2-A65E-2690567B77E9}" type="datetimeFigureOut">
              <a:rPr lang="en-ZA" smtClean="0"/>
              <a:t>2021/05/13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7BDA56-5D76-474F-9E22-EB45C3B9E71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0559239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09603" y="274638"/>
            <a:ext cx="109728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3" y="1600205"/>
            <a:ext cx="109728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09600" y="6356355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E713D0-FB24-4EC2-A65E-2690567B77E9}" type="datetimeFigureOut">
              <a:rPr lang="en-ZA" smtClean="0"/>
              <a:t>2021/05/13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165600" y="6356355"/>
            <a:ext cx="3860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737603" y="6356355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7BDA56-5D76-474F-9E22-EB45C3B9E71D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8331268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>
            <a:extLst>
              <a:ext uri="{FF2B5EF4-FFF2-40B4-BE49-F238E27FC236}">
                <a16:creationId xmlns:a16="http://schemas.microsoft.com/office/drawing/2014/main" id="{497F90FD-0B4C-4A93-8968-45DF7B369B44}"/>
              </a:ext>
            </a:extLst>
          </p:cNvPr>
          <p:cNvSpPr/>
          <p:nvPr/>
        </p:nvSpPr>
        <p:spPr>
          <a:xfrm>
            <a:off x="0" y="620688"/>
            <a:ext cx="181331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ZA" i="1" dirty="0">
                <a:latin typeface="Arial" panose="020B0604020202020204" pitchFamily="34" charset="0"/>
                <a:cs typeface="Arial" panose="020B0604020202020204" pitchFamily="34" charset="0"/>
              </a:rPr>
              <a:t>N. benthamiana</a:t>
            </a:r>
            <a:endParaRPr lang="en-GB" dirty="0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57C555F3-B85E-4BFF-9594-894630BC19D5}"/>
              </a:ext>
            </a:extLst>
          </p:cNvPr>
          <p:cNvSpPr/>
          <p:nvPr/>
        </p:nvSpPr>
        <p:spPr>
          <a:xfrm>
            <a:off x="-96688" y="3429000"/>
            <a:ext cx="104387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ZA" dirty="0">
                <a:latin typeface="Arial" panose="020B0604020202020204" pitchFamily="34" charset="0"/>
                <a:cs typeface="Arial" panose="020B0604020202020204" pitchFamily="34" charset="0"/>
              </a:rPr>
              <a:t>HEK293</a:t>
            </a:r>
            <a:endParaRPr lang="en-GB" dirty="0"/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9F2F72CB-B26E-4B53-90F2-7E920012560C}"/>
              </a:ext>
            </a:extLst>
          </p:cNvPr>
          <p:cNvGrpSpPr/>
          <p:nvPr/>
        </p:nvGrpSpPr>
        <p:grpSpPr>
          <a:xfrm>
            <a:off x="-96688" y="542967"/>
            <a:ext cx="12288688" cy="8996519"/>
            <a:chOff x="-96688" y="542967"/>
            <a:chExt cx="12288688" cy="8996519"/>
          </a:xfrm>
        </p:grpSpPr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id="{80098D17-C07D-4348-BE4B-409243D99C7A}"/>
                </a:ext>
              </a:extLst>
            </p:cNvPr>
            <p:cNvGrpSpPr/>
            <p:nvPr/>
          </p:nvGrpSpPr>
          <p:grpSpPr>
            <a:xfrm>
              <a:off x="-11188" y="542967"/>
              <a:ext cx="12203188" cy="5783659"/>
              <a:chOff x="-11188" y="542967"/>
              <a:chExt cx="12203188" cy="5783659"/>
            </a:xfrm>
          </p:grpSpPr>
          <p:pic>
            <p:nvPicPr>
              <p:cNvPr id="5" name="Picture 4">
                <a:extLst>
                  <a:ext uri="{FF2B5EF4-FFF2-40B4-BE49-F238E27FC236}">
                    <a16:creationId xmlns:a16="http://schemas.microsoft.com/office/drawing/2014/main" id="{FB74480A-42B7-42AF-8A35-ECAC8AE15A4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-11188" y="542967"/>
                <a:ext cx="12192000" cy="2886033"/>
              </a:xfrm>
              <a:prstGeom prst="rect">
                <a:avLst/>
              </a:prstGeom>
            </p:spPr>
          </p:pic>
          <p:pic>
            <p:nvPicPr>
              <p:cNvPr id="6" name="Picture 5">
                <a:extLst>
                  <a:ext uri="{FF2B5EF4-FFF2-40B4-BE49-F238E27FC236}">
                    <a16:creationId xmlns:a16="http://schemas.microsoft.com/office/drawing/2014/main" id="{95C53612-BDAE-4F27-BCCE-94F5781F610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0" y="3456508"/>
                <a:ext cx="12192000" cy="2870118"/>
              </a:xfrm>
              <a:prstGeom prst="rect">
                <a:avLst/>
              </a:prstGeom>
            </p:spPr>
          </p:pic>
        </p:grpSp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8FF8CB1A-F254-45D2-86F5-52F85EA3621C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0" y="6696868"/>
              <a:ext cx="6803391" cy="2842618"/>
            </a:xfrm>
            <a:prstGeom prst="rect">
              <a:avLst/>
            </a:prstGeom>
          </p:spPr>
        </p:pic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id="{CED26508-FDD1-4B55-9FB7-2879BF9759DE}"/>
                </a:ext>
              </a:extLst>
            </p:cNvPr>
            <p:cNvSpPr/>
            <p:nvPr/>
          </p:nvSpPr>
          <p:spPr>
            <a:xfrm>
              <a:off x="-96688" y="6336828"/>
              <a:ext cx="10591361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ZA" dirty="0">
                  <a:latin typeface="Arial" panose="020B0604020202020204" pitchFamily="34" charset="0"/>
                  <a:cs typeface="Arial" panose="020B0604020202020204" pitchFamily="34" charset="0"/>
                </a:rPr>
                <a:t>Percentage point change when expressed in </a:t>
              </a:r>
              <a:r>
                <a:rPr lang="en-ZA" i="1" dirty="0">
                  <a:latin typeface="Arial" panose="020B0604020202020204" pitchFamily="34" charset="0"/>
                  <a:cs typeface="Arial" panose="020B0604020202020204" pitchFamily="34" charset="0"/>
                </a:rPr>
                <a:t>N.benthamiana </a:t>
              </a:r>
              <a:r>
                <a:rPr lang="en-ZA" dirty="0">
                  <a:latin typeface="Arial" panose="020B0604020202020204" pitchFamily="34" charset="0"/>
                  <a:cs typeface="Arial" panose="020B0604020202020204" pitchFamily="34" charset="0"/>
                </a:rPr>
                <a:t>(+ve value is elevated in </a:t>
              </a:r>
              <a:r>
                <a:rPr lang="en-ZA" i="1" dirty="0">
                  <a:latin typeface="Arial" panose="020B0604020202020204" pitchFamily="34" charset="0"/>
                  <a:cs typeface="Arial" panose="020B0604020202020204" pitchFamily="34" charset="0"/>
                </a:rPr>
                <a:t>N.benthamiana</a:t>
              </a:r>
              <a:r>
                <a:rPr lang="en-ZA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14473143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943</TotalTime>
  <Words>23</Words>
  <Application>Microsoft Office PowerPoint</Application>
  <PresentationFormat>Widescreen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University of Cape Tow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indows User</dc:creator>
  <cp:lastModifiedBy>Emmanuel Margolin</cp:lastModifiedBy>
  <cp:revision>176</cp:revision>
  <cp:lastPrinted>2019-09-17T11:35:12Z</cp:lastPrinted>
  <dcterms:created xsi:type="dcterms:W3CDTF">2019-08-13T08:19:27Z</dcterms:created>
  <dcterms:modified xsi:type="dcterms:W3CDTF">2021-05-13T15:45:03Z</dcterms:modified>
</cp:coreProperties>
</file>